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ED8E6"/>
    <a:srgbClr val="FF4400"/>
    <a:srgbClr val="3B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31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30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809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3018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09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243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800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831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508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7925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00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413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08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86B862-1A1D-4940-8C27-65CFFACA5084}" type="datetimeFigureOut">
              <a:rPr lang="fr-FR" smtClean="0"/>
              <a:t>15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98299-702D-4B59-870E-F4FD43177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767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DC8D1D7-1C66-244F-77E5-1C3C4BDEB1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2846"/>
          <a:stretch/>
        </p:blipFill>
        <p:spPr>
          <a:xfrm>
            <a:off x="979682" y="1371500"/>
            <a:ext cx="3278304" cy="496638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B2DD6FD-182A-289B-65C2-EDAF26F70E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6380" y="407400"/>
            <a:ext cx="3896637" cy="2783312"/>
          </a:xfrm>
          <a:prstGeom prst="rect">
            <a:avLst/>
          </a:prstGeom>
        </p:spPr>
      </p:pic>
      <p:pic>
        <p:nvPicPr>
          <p:cNvPr id="4" name="Picture 7">
            <a:extLst>
              <a:ext uri="{FF2B5EF4-FFF2-40B4-BE49-F238E27FC236}">
                <a16:creationId xmlns:a16="http://schemas.microsoft.com/office/drawing/2014/main" id="{EE4C7F4C-A2FE-5511-C572-09C05B0EFC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8516" y="3327366"/>
            <a:ext cx="4372363" cy="3123234"/>
          </a:xfrm>
          <a:prstGeom prst="rect">
            <a:avLst/>
          </a:prstGeom>
        </p:spPr>
      </p:pic>
      <p:pic>
        <p:nvPicPr>
          <p:cNvPr id="5" name="Picture 1">
            <a:extLst>
              <a:ext uri="{FF2B5EF4-FFF2-40B4-BE49-F238E27FC236}">
                <a16:creationId xmlns:a16="http://schemas.microsoft.com/office/drawing/2014/main" id="{4DF50798-EC47-87E7-0001-AB7B1A9DEED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5653" t="19195" r="387" b="56410"/>
          <a:stretch/>
        </p:blipFill>
        <p:spPr>
          <a:xfrm>
            <a:off x="4297493" y="1281186"/>
            <a:ext cx="1232562" cy="153863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7ADD2DF-13B7-1DD9-E35B-DC0BAC78FE38}"/>
              </a:ext>
            </a:extLst>
          </p:cNvPr>
          <p:cNvSpPr/>
          <p:nvPr/>
        </p:nvSpPr>
        <p:spPr>
          <a:xfrm>
            <a:off x="3860023" y="5483794"/>
            <a:ext cx="755010" cy="5536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A15E6154-1DE5-6F5B-3CAD-BC4B2C5E28B5}"/>
              </a:ext>
            </a:extLst>
          </p:cNvPr>
          <p:cNvCxnSpPr/>
          <p:nvPr/>
        </p:nvCxnSpPr>
        <p:spPr>
          <a:xfrm>
            <a:off x="5793997" y="617264"/>
            <a:ext cx="0" cy="5420203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6962FE49-A364-2A5A-D15E-799EC97DBDA6}"/>
              </a:ext>
            </a:extLst>
          </p:cNvPr>
          <p:cNvCxnSpPr>
            <a:cxnSpLocks/>
          </p:cNvCxnSpPr>
          <p:nvPr/>
        </p:nvCxnSpPr>
        <p:spPr>
          <a:xfrm flipH="1">
            <a:off x="5793997" y="3429000"/>
            <a:ext cx="5115759" cy="0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1" name="ZoneTexte 10">
            <a:extLst>
              <a:ext uri="{FF2B5EF4-FFF2-40B4-BE49-F238E27FC236}">
                <a16:creationId xmlns:a16="http://schemas.microsoft.com/office/drawing/2014/main" id="{A9D32DB8-0187-EF07-B17B-1EA377073184}"/>
              </a:ext>
            </a:extLst>
          </p:cNvPr>
          <p:cNvSpPr txBox="1"/>
          <p:nvPr/>
        </p:nvSpPr>
        <p:spPr>
          <a:xfrm>
            <a:off x="1548544" y="520116"/>
            <a:ext cx="11325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A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D63C28B-FB67-640F-50FC-C59F79C7B156}"/>
              </a:ext>
            </a:extLst>
          </p:cNvPr>
          <p:cNvSpPr txBox="1"/>
          <p:nvPr/>
        </p:nvSpPr>
        <p:spPr>
          <a:xfrm>
            <a:off x="5950592" y="520116"/>
            <a:ext cx="11325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07D9831-8AF7-6C10-2BE0-CDDED9B7C429}"/>
              </a:ext>
            </a:extLst>
          </p:cNvPr>
          <p:cNvSpPr txBox="1"/>
          <p:nvPr/>
        </p:nvSpPr>
        <p:spPr>
          <a:xfrm>
            <a:off x="5921231" y="3568354"/>
            <a:ext cx="11325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/>
              <a:t>C</a:t>
            </a:r>
            <a:endParaRPr lang="fr-FR" sz="2400" b="1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5551C4-60C5-D108-978C-76365C64F3A4}"/>
              </a:ext>
            </a:extLst>
          </p:cNvPr>
          <p:cNvSpPr/>
          <p:nvPr/>
        </p:nvSpPr>
        <p:spPr>
          <a:xfrm>
            <a:off x="4158764" y="3014681"/>
            <a:ext cx="755010" cy="5536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26917EF-B00E-A9F1-EBCA-4B92D03C0633}"/>
              </a:ext>
            </a:extLst>
          </p:cNvPr>
          <p:cNvSpPr/>
          <p:nvPr/>
        </p:nvSpPr>
        <p:spPr>
          <a:xfrm>
            <a:off x="1285228" y="4406818"/>
            <a:ext cx="3463753" cy="1875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5F03CFC8-3A60-0423-8946-20131EE8FE70}"/>
              </a:ext>
            </a:extLst>
          </p:cNvPr>
          <p:cNvSpPr txBox="1"/>
          <p:nvPr/>
        </p:nvSpPr>
        <p:spPr>
          <a:xfrm rot="19193297">
            <a:off x="-315510" y="5117052"/>
            <a:ext cx="31119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CCC </a:t>
            </a:r>
            <a:r>
              <a:rPr lang="fr-FR" sz="1600" dirty="0" err="1"/>
              <a:t>correlation</a:t>
            </a:r>
            <a:r>
              <a:rPr lang="fr-FR" sz="1600" dirty="0"/>
              <a:t> for </a:t>
            </a:r>
          </a:p>
          <a:p>
            <a:pPr algn="r"/>
            <a:r>
              <a:rPr lang="fr-FR" sz="1600" dirty="0"/>
              <a:t>|CTRL </a:t>
            </a:r>
            <a:r>
              <a:rPr lang="fr-FR" sz="1600" dirty="0" err="1"/>
              <a:t>correlation</a:t>
            </a:r>
            <a:r>
              <a:rPr lang="fr-FR" sz="1600" dirty="0"/>
              <a:t>| ≥ 0.8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3A002C3F-78AD-F5E9-B05E-AA3AC05C7762}"/>
              </a:ext>
            </a:extLst>
          </p:cNvPr>
          <p:cNvSpPr txBox="1"/>
          <p:nvPr/>
        </p:nvSpPr>
        <p:spPr>
          <a:xfrm rot="19193297">
            <a:off x="958774" y="5117051"/>
            <a:ext cx="31119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600" dirty="0"/>
              <a:t>CTRL </a:t>
            </a:r>
            <a:r>
              <a:rPr lang="fr-FR" sz="1600" dirty="0" err="1"/>
              <a:t>correlation</a:t>
            </a:r>
            <a:r>
              <a:rPr lang="fr-FR" sz="1600" dirty="0"/>
              <a:t> for </a:t>
            </a:r>
          </a:p>
          <a:p>
            <a:pPr algn="r"/>
            <a:r>
              <a:rPr lang="fr-FR" sz="1600" dirty="0"/>
              <a:t>|CCC </a:t>
            </a:r>
            <a:r>
              <a:rPr lang="fr-FR" sz="1600" dirty="0" err="1"/>
              <a:t>correlation</a:t>
            </a:r>
            <a:r>
              <a:rPr lang="fr-FR" sz="1600" dirty="0"/>
              <a:t>| ≥ 0.8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41C445B5-15E3-5181-15DF-F08E805B8A97}"/>
              </a:ext>
            </a:extLst>
          </p:cNvPr>
          <p:cNvSpPr txBox="1"/>
          <p:nvPr/>
        </p:nvSpPr>
        <p:spPr>
          <a:xfrm>
            <a:off x="6577777" y="238123"/>
            <a:ext cx="79641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dirty="0"/>
              <a:t>49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0F36B5DA-0094-C9EC-75C8-663718A8031A}"/>
              </a:ext>
            </a:extLst>
          </p:cNvPr>
          <p:cNvSpPr txBox="1"/>
          <p:nvPr/>
        </p:nvSpPr>
        <p:spPr>
          <a:xfrm>
            <a:off x="10183412" y="255757"/>
            <a:ext cx="79641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dirty="0"/>
              <a:t>4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6BDE878-8AB7-50FB-4B9C-2F392BC063F8}"/>
              </a:ext>
            </a:extLst>
          </p:cNvPr>
          <p:cNvSpPr txBox="1"/>
          <p:nvPr/>
        </p:nvSpPr>
        <p:spPr>
          <a:xfrm>
            <a:off x="8298782" y="1595926"/>
            <a:ext cx="79641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dirty="0"/>
              <a:t>2013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659A2B24-CBC3-719F-1078-DF990928FE69}"/>
              </a:ext>
            </a:extLst>
          </p:cNvPr>
          <p:cNvSpPr txBox="1"/>
          <p:nvPr/>
        </p:nvSpPr>
        <p:spPr>
          <a:xfrm>
            <a:off x="7224378" y="4719706"/>
            <a:ext cx="9177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dirty="0"/>
              <a:t>197642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AB22DB8-2869-BD12-C19F-F05C9E66B421}"/>
              </a:ext>
            </a:extLst>
          </p:cNvPr>
          <p:cNvSpPr txBox="1"/>
          <p:nvPr/>
        </p:nvSpPr>
        <p:spPr>
          <a:xfrm>
            <a:off x="9699775" y="4719706"/>
            <a:ext cx="9177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dirty="0"/>
              <a:t>85398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457B0150-6785-2B59-A069-8995F2295A10}"/>
              </a:ext>
            </a:extLst>
          </p:cNvPr>
          <p:cNvSpPr txBox="1"/>
          <p:nvPr/>
        </p:nvSpPr>
        <p:spPr>
          <a:xfrm>
            <a:off x="6523689" y="2681439"/>
            <a:ext cx="54237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1600" b="1" dirty="0">
                <a:solidFill>
                  <a:srgbClr val="FF4400"/>
                </a:solidFill>
              </a:rPr>
              <a:t>CCC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20488961-A388-E715-086D-D193DD75B98A}"/>
              </a:ext>
            </a:extLst>
          </p:cNvPr>
          <p:cNvSpPr txBox="1"/>
          <p:nvPr/>
        </p:nvSpPr>
        <p:spPr>
          <a:xfrm>
            <a:off x="6252500" y="5581675"/>
            <a:ext cx="54237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fr-FR" sz="1600" b="1" dirty="0">
                <a:solidFill>
                  <a:srgbClr val="FF4400"/>
                </a:solidFill>
              </a:rPr>
              <a:t>CCC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D92FEEE-BE5E-745D-C7E0-E62B1F318FD1}"/>
              </a:ext>
            </a:extLst>
          </p:cNvPr>
          <p:cNvSpPr txBox="1"/>
          <p:nvPr/>
        </p:nvSpPr>
        <p:spPr>
          <a:xfrm>
            <a:off x="10406780" y="5365633"/>
            <a:ext cx="64884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b="1" dirty="0">
                <a:solidFill>
                  <a:srgbClr val="AED8E6"/>
                </a:solidFill>
              </a:rPr>
              <a:t>CTRL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A6F77338-1E4F-46CA-0FEF-70B4B9990A64}"/>
              </a:ext>
            </a:extLst>
          </p:cNvPr>
          <p:cNvSpPr txBox="1"/>
          <p:nvPr/>
        </p:nvSpPr>
        <p:spPr>
          <a:xfrm>
            <a:off x="9957071" y="2670707"/>
            <a:ext cx="64884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600" b="1" dirty="0">
                <a:solidFill>
                  <a:srgbClr val="AED8E6"/>
                </a:solidFill>
              </a:rPr>
              <a:t>CTRL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9AD6FA0-C4A0-3783-A834-1DFB3A97AC35}"/>
              </a:ext>
            </a:extLst>
          </p:cNvPr>
          <p:cNvSpPr/>
          <p:nvPr/>
        </p:nvSpPr>
        <p:spPr>
          <a:xfrm>
            <a:off x="8843133" y="4770523"/>
            <a:ext cx="252062" cy="196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56A5ED7-211E-6A56-A886-D0925D344185}"/>
              </a:ext>
            </a:extLst>
          </p:cNvPr>
          <p:cNvSpPr txBox="1"/>
          <p:nvPr/>
        </p:nvSpPr>
        <p:spPr>
          <a:xfrm>
            <a:off x="8636342" y="4699612"/>
            <a:ext cx="917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30815</a:t>
            </a:r>
          </a:p>
        </p:txBody>
      </p:sp>
    </p:spTree>
    <p:extLst>
      <p:ext uri="{BB962C8B-B14F-4D97-AF65-F5344CB8AC3E}">
        <p14:creationId xmlns:p14="http://schemas.microsoft.com/office/powerpoint/2010/main" val="31067846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6</TotalTime>
  <Words>31</Words>
  <Application>Microsoft Office PowerPoint</Application>
  <PresentationFormat>Grand écran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uline Brochet</dc:creator>
  <cp:lastModifiedBy>Pauline Brochet</cp:lastModifiedBy>
  <cp:revision>14</cp:revision>
  <dcterms:created xsi:type="dcterms:W3CDTF">2023-09-28T23:06:01Z</dcterms:created>
  <dcterms:modified xsi:type="dcterms:W3CDTF">2023-10-15T13:32:27Z</dcterms:modified>
</cp:coreProperties>
</file>